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D450F4-E083-456A-8F44-7F43563274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015DB-C151-4187-9682-79D5424928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7AD26-A551-4D01-A270-BB849BE159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F4950-C802-4A85-B5CA-9883173594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B1428-66B8-44B3-A9C7-652498F442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7959B-FD15-4C98-B25C-EF561B2BC2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6ABE4-E032-4071-802D-17C37299D1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D40C96-0FFE-48A7-B36F-F401C9BCAC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209CE-9808-4FF1-8D8B-4F0FE031FD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3E7F0E-963A-41CB-90BC-105E01EB26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927FD-4B78-4D89-8CC9-53F3C9FB69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434CBD-C1AA-4900-858B-104363B39A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E8DC02-4EBC-47F8-9477-6680AFD9F3CD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985680" y="2728800"/>
            <a:ext cx="2060640" cy="3976920"/>
          </a:xfrm>
          <a:prstGeom prst="rect">
            <a:avLst/>
          </a:prstGeom>
          <a:ln w="0">
            <a:noFill/>
          </a:ln>
        </p:spPr>
      </p:pic>
      <p:sp>
        <p:nvSpPr>
          <p:cNvPr id="42" name="Textfeld 2"/>
          <p:cNvSpPr/>
          <p:nvPr/>
        </p:nvSpPr>
        <p:spPr>
          <a:xfrm>
            <a:off x="4191120" y="2743200"/>
            <a:ext cx="43434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Calibri"/>
              </a:rPr>
              <a:t>Additional file 8:</a:t>
            </a:r>
            <a:r>
              <a:rPr b="0" lang="de-DE" sz="1200" spc="-1" strike="noStrike">
                <a:solidFill>
                  <a:srgbClr val="000000"/>
                </a:solidFill>
                <a:latin typeface="Calibri"/>
              </a:rPr>
              <a:t> Comparision of the methylation frequency [%] of genes previously determined by other authors (Chu et al., 2006; Gonzalez-Gomez et al., 2003) using MSP and this study. To calculate frequency based on the date obtained from the GoldenGate array, AVG-beta values above 0.3 where considered as methylat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feld 3"/>
          <p:cNvSpPr/>
          <p:nvPr/>
        </p:nvSpPr>
        <p:spPr>
          <a:xfrm rot="16200000">
            <a:off x="1584360" y="2164680"/>
            <a:ext cx="85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Calibri"/>
              </a:rPr>
              <a:t>contro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feld 4"/>
          <p:cNvSpPr/>
          <p:nvPr/>
        </p:nvSpPr>
        <p:spPr>
          <a:xfrm rot="16200000">
            <a:off x="2069280" y="2237040"/>
            <a:ext cx="703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Calibri"/>
              </a:rPr>
              <a:t>PCNS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feld 5"/>
          <p:cNvSpPr/>
          <p:nvPr/>
        </p:nvSpPr>
        <p:spPr>
          <a:xfrm rot="16200000">
            <a:off x="1912320" y="1663560"/>
            <a:ext cx="184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Calibri"/>
              </a:rPr>
              <a:t>PCNSL        literatur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feld 6"/>
          <p:cNvSpPr/>
          <p:nvPr/>
        </p:nvSpPr>
        <p:spPr>
          <a:xfrm rot="16200000">
            <a:off x="1584720" y="1037880"/>
            <a:ext cx="129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GoldenG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Gerade Verbindung 8"/>
          <p:cNvSpPr/>
          <p:nvPr/>
        </p:nvSpPr>
        <p:spPr>
          <a:xfrm>
            <a:off x="1824120" y="1854360"/>
            <a:ext cx="83808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feld 10"/>
          <p:cNvSpPr/>
          <p:nvPr/>
        </p:nvSpPr>
        <p:spPr>
          <a:xfrm rot="16200000">
            <a:off x="2612160" y="4649760"/>
            <a:ext cx="2056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Calibri"/>
              </a:rPr>
              <a:t>methylation frequenc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feil nach unten 11"/>
          <p:cNvSpPr/>
          <p:nvPr/>
        </p:nvSpPr>
        <p:spPr>
          <a:xfrm rot="10800000">
            <a:off x="3195720" y="3504960"/>
            <a:ext cx="380880" cy="2514600"/>
          </a:xfrm>
          <a:prstGeom prst="downArrow">
            <a:avLst>
              <a:gd name="adj1" fmla="val 50000"/>
              <a:gd name="adj2" fmla="val 50005"/>
            </a:avLst>
          </a:prstGeom>
          <a:gradFill rotWithShape="0">
            <a:gsLst>
              <a:gs pos="0">
                <a:srgbClr val="4f81bd"/>
              </a:gs>
              <a:gs pos="100000">
                <a:srgbClr val="ffff00"/>
              </a:gs>
            </a:gsLst>
            <a:lin ang="54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1T17:30:16Z</dcterms:created>
  <dc:creator>standard</dc:creator>
  <dc:description/>
  <dc:language>en-US</dc:language>
  <cp:lastModifiedBy>Nobody</cp:lastModifiedBy>
  <dcterms:modified xsi:type="dcterms:W3CDTF">2009-12-14T06:28:35Z</dcterms:modified>
  <cp:revision>92</cp:revision>
  <dc:subject/>
  <dc:title>Folie 1</dc:title>
</cp:coreProperties>
</file>